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125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921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73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20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179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90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471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932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297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429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755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4A2BC-7C98-47E1-B40C-BD3F8104D393}" type="datetimeFigureOut">
              <a:rPr lang="en-US" smtClean="0"/>
              <a:t>11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1577EB-7CED-4E17-AE86-84153499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18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0451" y="2647302"/>
            <a:ext cx="5619750" cy="401955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 flipH="1" flipV="1">
            <a:off x="3172028" y="4531459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485622" y="4362969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85 </a:t>
            </a:r>
            <a:r>
              <a:rPr lang="en-US" sz="1400" dirty="0" err="1"/>
              <a:t>k</a:t>
            </a:r>
            <a:r>
              <a:rPr lang="en-US" sz="1400" dirty="0" err="1" smtClean="0"/>
              <a:t>Da</a:t>
            </a:r>
            <a:endParaRPr lang="en-US" sz="1400" dirty="0"/>
          </a:p>
        </p:txBody>
      </p:sp>
      <p:cxnSp>
        <p:nvCxnSpPr>
          <p:cNvPr id="7" name="Straight Arrow Connector 6"/>
          <p:cNvCxnSpPr/>
          <p:nvPr/>
        </p:nvCxnSpPr>
        <p:spPr>
          <a:xfrm flipH="1" flipV="1">
            <a:off x="3172028" y="4297712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397199" y="4156604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20 </a:t>
            </a:r>
            <a:r>
              <a:rPr lang="en-US" sz="1400" dirty="0" err="1"/>
              <a:t>k</a:t>
            </a:r>
            <a:r>
              <a:rPr lang="en-US" sz="1400" dirty="0" err="1" smtClean="0"/>
              <a:t>Da</a:t>
            </a:r>
            <a:endParaRPr lang="en-US" sz="1400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6485117" y="4518578"/>
            <a:ext cx="3431615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0177197" y="4333912"/>
            <a:ext cx="16326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F2 bands</a:t>
            </a:r>
          </a:p>
          <a:p>
            <a:r>
              <a:rPr lang="en-US" dirty="0" smtClean="0"/>
              <a:t>(</a:t>
            </a:r>
            <a:r>
              <a:rPr lang="en-US" dirty="0" err="1" smtClean="0"/>
              <a:t>Mwt</a:t>
            </a:r>
            <a:r>
              <a:rPr lang="en-US" dirty="0" smtClean="0"/>
              <a:t> 100  </a:t>
            </a:r>
            <a:r>
              <a:rPr lang="en-US" dirty="0" err="1" smtClean="0"/>
              <a:t>kDa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5031688" y="1861526"/>
            <a:ext cx="69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5377604" y="2286844"/>
            <a:ext cx="0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5339876" y="1861526"/>
            <a:ext cx="69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5698669" y="2286844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6052815" y="2286843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V="1">
            <a:off x="6406961" y="2286842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 rot="16200000">
            <a:off x="5614771" y="1765373"/>
            <a:ext cx="829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lu3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994277" y="1755488"/>
            <a:ext cx="829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lu3</a:t>
            </a:r>
            <a:endParaRPr lang="en-US" dirty="0"/>
          </a:p>
        </p:txBody>
      </p:sp>
      <p:cxnSp>
        <p:nvCxnSpPr>
          <p:cNvPr id="21" name="Straight Arrow Connector 20"/>
          <p:cNvCxnSpPr/>
          <p:nvPr/>
        </p:nvCxnSpPr>
        <p:spPr>
          <a:xfrm flipH="1" flipV="1">
            <a:off x="3172028" y="4180838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397199" y="3972240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40 </a:t>
            </a:r>
            <a:r>
              <a:rPr lang="en-US" sz="1400" dirty="0" err="1"/>
              <a:t>k</a:t>
            </a:r>
            <a:r>
              <a:rPr lang="en-US" sz="1400" dirty="0" err="1" smtClean="0"/>
              <a:t>Da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5013438" y="1058091"/>
            <a:ext cx="287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IB:NRF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1677" y="1124320"/>
            <a:ext cx="287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Fig: A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77331" y="210371"/>
            <a:ext cx="1062438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Low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The original full length blots (uncropped). A) IB: NRF2. B) IB:NR0B1. C)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B:Actin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Low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experiment was done in duplicates to compare the levels of NRF2 and NR0B1 between A549</a:t>
            </a:r>
          </a:p>
          <a:p>
            <a:pPr algn="justLow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AP1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utant LUAD cell line</a:t>
            </a:r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Calu3 (Non </a:t>
            </a:r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AP1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utant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AD cell line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). Actin was used as an internal control.</a:t>
            </a:r>
            <a:endParaRPr lang="en-US" sz="1600" dirty="0"/>
          </a:p>
        </p:txBody>
      </p:sp>
      <p:sp>
        <p:nvSpPr>
          <p:cNvPr id="2" name="Rectangle 1"/>
          <p:cNvSpPr/>
          <p:nvPr/>
        </p:nvSpPr>
        <p:spPr>
          <a:xfrm>
            <a:off x="5557608" y="4333912"/>
            <a:ext cx="656823" cy="29621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349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58246" y="423204"/>
            <a:ext cx="2877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NR0B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5055" y="1595052"/>
            <a:ext cx="5753100" cy="4257675"/>
          </a:xfrm>
          <a:prstGeom prst="rect">
            <a:avLst/>
          </a:prstGeom>
        </p:spPr>
      </p:pic>
      <p:cxnSp>
        <p:nvCxnSpPr>
          <p:cNvPr id="8" name="Straight Arrow Connector 7"/>
          <p:cNvCxnSpPr/>
          <p:nvPr/>
        </p:nvCxnSpPr>
        <p:spPr>
          <a:xfrm flipH="1" flipV="1">
            <a:off x="2665927" y="3308546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885281" y="311099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0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6201782" y="3295665"/>
            <a:ext cx="3431615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9893862" y="3110999"/>
            <a:ext cx="14627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0B1 bands</a:t>
            </a:r>
          </a:p>
          <a:p>
            <a:r>
              <a:rPr lang="en-US" dirty="0" smtClean="0"/>
              <a:t>(</a:t>
            </a:r>
            <a:r>
              <a:rPr lang="en-US" dirty="0" err="1" smtClean="0"/>
              <a:t>Mwt</a:t>
            </a:r>
            <a:r>
              <a:rPr lang="en-US" dirty="0" smtClean="0"/>
              <a:t> 52 </a:t>
            </a:r>
            <a:r>
              <a:rPr lang="en-US" dirty="0" err="1" smtClean="0"/>
              <a:t>kDa</a:t>
            </a:r>
            <a:r>
              <a:rPr lang="en-US" dirty="0" smtClean="0"/>
              <a:t>)</a:t>
            </a:r>
            <a:endParaRPr lang="en-US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 flipV="1">
            <a:off x="2656873" y="3550255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885281" y="335455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5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 flipV="1">
            <a:off x="2656873" y="3779083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885281" y="3598115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5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22" name="Straight Arrow Connector 21"/>
          <p:cNvCxnSpPr/>
          <p:nvPr/>
        </p:nvCxnSpPr>
        <p:spPr>
          <a:xfrm flipH="1" flipV="1">
            <a:off x="2656873" y="3110999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876161" y="2877252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85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658201" y="891825"/>
            <a:ext cx="69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cxnSp>
        <p:nvCxnSpPr>
          <p:cNvPr id="25" name="Straight Arrow Connector 24"/>
          <p:cNvCxnSpPr/>
          <p:nvPr/>
        </p:nvCxnSpPr>
        <p:spPr>
          <a:xfrm flipV="1">
            <a:off x="5004117" y="1317143"/>
            <a:ext cx="0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 rot="16200000">
            <a:off x="4966389" y="891825"/>
            <a:ext cx="69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cxnSp>
        <p:nvCxnSpPr>
          <p:cNvPr id="29" name="Straight Arrow Connector 28"/>
          <p:cNvCxnSpPr/>
          <p:nvPr/>
        </p:nvCxnSpPr>
        <p:spPr>
          <a:xfrm flipV="1">
            <a:off x="5325182" y="1317143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V="1">
            <a:off x="5679328" y="1317142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V="1">
            <a:off x="6033474" y="1317141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5241284" y="795672"/>
            <a:ext cx="829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lu3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5620790" y="785787"/>
            <a:ext cx="829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lu3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133297" y="110706"/>
            <a:ext cx="287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Fig: B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5164632" y="3219329"/>
            <a:ext cx="656823" cy="14810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3708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5700" y="1472524"/>
            <a:ext cx="4800600" cy="405765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4851382" y="836712"/>
            <a:ext cx="69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5197298" y="1262030"/>
            <a:ext cx="0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5159570" y="836712"/>
            <a:ext cx="69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549</a:t>
            </a:r>
            <a:endParaRPr lang="en-US" dirty="0"/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5518363" y="1262030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5872509" y="1262029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V="1">
            <a:off x="6226655" y="1262028"/>
            <a:ext cx="1" cy="174477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 rot="16200000">
            <a:off x="5434465" y="740559"/>
            <a:ext cx="829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lu3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813971" y="730674"/>
            <a:ext cx="829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lu3</a:t>
            </a:r>
            <a:endParaRPr lang="en-US" dirty="0"/>
          </a:p>
        </p:txBody>
      </p:sp>
      <p:cxnSp>
        <p:nvCxnSpPr>
          <p:cNvPr id="21" name="Straight Arrow Connector 20"/>
          <p:cNvCxnSpPr/>
          <p:nvPr/>
        </p:nvCxnSpPr>
        <p:spPr>
          <a:xfrm flipH="1" flipV="1">
            <a:off x="2884870" y="3073128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104224" y="287558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0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23" name="Straight Arrow Connector 22"/>
          <p:cNvCxnSpPr/>
          <p:nvPr/>
        </p:nvCxnSpPr>
        <p:spPr>
          <a:xfrm flipH="1" flipV="1">
            <a:off x="2875816" y="3314837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104224" y="311913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5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25" name="Straight Arrow Connector 24"/>
          <p:cNvCxnSpPr/>
          <p:nvPr/>
        </p:nvCxnSpPr>
        <p:spPr>
          <a:xfrm flipH="1" flipV="1">
            <a:off x="2875816" y="3543665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104224" y="336269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5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27" name="Straight Arrow Connector 26"/>
          <p:cNvCxnSpPr/>
          <p:nvPr/>
        </p:nvCxnSpPr>
        <p:spPr>
          <a:xfrm flipH="1" flipV="1">
            <a:off x="2875816" y="2875581"/>
            <a:ext cx="1841410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095104" y="2641834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85 </a:t>
            </a:r>
            <a:r>
              <a:rPr lang="en-US" dirty="0" err="1"/>
              <a:t>k</a:t>
            </a:r>
            <a:r>
              <a:rPr lang="en-US" dirty="0" err="1" smtClean="0"/>
              <a:t>Da</a:t>
            </a:r>
            <a:endParaRPr lang="en-US" dirty="0"/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6413631" y="3314837"/>
            <a:ext cx="3431615" cy="12881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0105711" y="3130171"/>
            <a:ext cx="15156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in bands</a:t>
            </a:r>
          </a:p>
          <a:p>
            <a:r>
              <a:rPr lang="en-US" dirty="0" smtClean="0"/>
              <a:t>(</a:t>
            </a:r>
            <a:r>
              <a:rPr lang="en-US" dirty="0" err="1" smtClean="0"/>
              <a:t>Mwt</a:t>
            </a:r>
            <a:r>
              <a:rPr lang="en-US" dirty="0" smtClean="0"/>
              <a:t> 42  </a:t>
            </a:r>
            <a:r>
              <a:rPr lang="en-US" dirty="0" err="1" smtClean="0"/>
              <a:t>kDa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4226066" y="344569"/>
            <a:ext cx="2877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IB: Actin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33297" y="16577"/>
            <a:ext cx="287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Fig: C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5387475" y="3173169"/>
            <a:ext cx="656823" cy="3153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093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143</Words>
  <Application>Microsoft Office PowerPoint</Application>
  <PresentationFormat>Widescreen</PresentationFormat>
  <Paragraphs>4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.Elshaer</dc:creator>
  <cp:lastModifiedBy>M.Elshaer</cp:lastModifiedBy>
  <cp:revision>12</cp:revision>
  <dcterms:created xsi:type="dcterms:W3CDTF">2021-06-09T11:13:15Z</dcterms:created>
  <dcterms:modified xsi:type="dcterms:W3CDTF">2021-11-21T08:39:46Z</dcterms:modified>
</cp:coreProperties>
</file>